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CBF4FA-C320-44A1-98CD-4F98D6D1DB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FBF884-0D22-423C-94E9-DF5FBDE81F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16DC3-2690-4171-BF6B-FB76CA99A9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47FA80-BCD4-4ED1-AF17-97D065AEC3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07284A-8D3D-42AD-8685-FF1E4EF132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044EC-7C4A-48FB-906B-DB81FBDF37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939B5C-9967-457D-BA44-20C5865A96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C4BEDF-D27A-4747-9D6E-AE2B73A114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477096-C0BC-4F3F-96C9-5589CF7B25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EFADA4-3CDC-476C-94D6-FA894E55E1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6AF19-FAB3-4D9B-B068-DB665D71BB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DB254A-A71B-4075-B4A6-E7C39A9FD0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9F56B6-0A48-4221-90D0-137BF1F11619}" type="slidenum"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4" descr=""/>
          <p:cNvPicPr/>
          <p:nvPr/>
        </p:nvPicPr>
        <p:blipFill>
          <a:blip r:embed="rId1"/>
          <a:stretch/>
        </p:blipFill>
        <p:spPr>
          <a:xfrm>
            <a:off x="230040" y="44280"/>
            <a:ext cx="684360" cy="17924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6" descr=""/>
          <p:cNvPicPr/>
          <p:nvPr/>
        </p:nvPicPr>
        <p:blipFill>
          <a:blip r:embed="rId2"/>
          <a:stretch/>
        </p:blipFill>
        <p:spPr>
          <a:xfrm>
            <a:off x="417600" y="5092560"/>
            <a:ext cx="420480" cy="16891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9" descr=""/>
          <p:cNvPicPr/>
          <p:nvPr/>
        </p:nvPicPr>
        <p:blipFill>
          <a:blip r:embed="rId3"/>
          <a:stretch/>
        </p:blipFill>
        <p:spPr>
          <a:xfrm>
            <a:off x="363600" y="1743120"/>
            <a:ext cx="536400" cy="16858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65" descr=""/>
          <p:cNvPicPr/>
          <p:nvPr/>
        </p:nvPicPr>
        <p:blipFill>
          <a:blip r:embed="rId4"/>
          <a:stretch/>
        </p:blipFill>
        <p:spPr>
          <a:xfrm>
            <a:off x="380880" y="3378240"/>
            <a:ext cx="568440" cy="1727280"/>
          </a:xfrm>
          <a:prstGeom prst="rect">
            <a:avLst/>
          </a:prstGeom>
          <a:ln w="0">
            <a:noFill/>
          </a:ln>
        </p:spPr>
      </p:pic>
      <p:sp>
        <p:nvSpPr>
          <p:cNvPr id="45" name="Text Box 2"/>
          <p:cNvSpPr/>
          <p:nvPr/>
        </p:nvSpPr>
        <p:spPr>
          <a:xfrm>
            <a:off x="2212920" y="896760"/>
            <a:ext cx="99072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PI3KC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and cancer</a:t>
            </a:r>
            <a:r>
              <a:rPr b="0" lang="es-E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Text Box 3"/>
          <p:cNvSpPr/>
          <p:nvPr/>
        </p:nvSpPr>
        <p:spPr>
          <a:xfrm>
            <a:off x="3203640" y="896760"/>
            <a:ext cx="1447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PI3KCA-mTOR and cancer</a:t>
            </a:r>
            <a:r>
              <a:rPr b="0" lang="es-E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Text Box 4"/>
          <p:cNvSpPr/>
          <p:nvPr/>
        </p:nvSpPr>
        <p:spPr>
          <a:xfrm>
            <a:off x="4643280" y="744480"/>
            <a:ext cx="1792440" cy="850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PI3KCA and each specific solid tumor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Text Box 5"/>
          <p:cNvSpPr/>
          <p:nvPr/>
        </p:nvSpPr>
        <p:spPr>
          <a:xfrm>
            <a:off x="6300720" y="733320"/>
            <a:ext cx="1828800" cy="850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TOR and the name of each specific solid tumor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Line 19"/>
          <p:cNvSpPr/>
          <p:nvPr/>
        </p:nvSpPr>
        <p:spPr>
          <a:xfrm>
            <a:off x="7164360" y="2344680"/>
            <a:ext cx="5335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Text Box 20"/>
          <p:cNvSpPr/>
          <p:nvPr/>
        </p:nvSpPr>
        <p:spPr>
          <a:xfrm>
            <a:off x="7956720" y="1963800"/>
            <a:ext cx="1143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Times New Roman"/>
              </a:rPr>
              <a:t>Identification of related article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Text Box 22"/>
          <p:cNvSpPr/>
          <p:nvPr/>
        </p:nvSpPr>
        <p:spPr>
          <a:xfrm>
            <a:off x="7924680" y="4437000"/>
            <a:ext cx="137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Times New Roman"/>
              </a:rPr>
              <a:t>3 articles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Text Box 27"/>
          <p:cNvSpPr/>
          <p:nvPr/>
        </p:nvSpPr>
        <p:spPr>
          <a:xfrm>
            <a:off x="1201680" y="836640"/>
            <a:ext cx="1066680" cy="850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PTEN loss and cancer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Line 28"/>
          <p:cNvSpPr/>
          <p:nvPr/>
        </p:nvSpPr>
        <p:spPr>
          <a:xfrm>
            <a:off x="1692360" y="1844640"/>
            <a:ext cx="0" cy="74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Rectangle 50"/>
          <p:cNvSpPr/>
          <p:nvPr/>
        </p:nvSpPr>
        <p:spPr>
          <a:xfrm>
            <a:off x="1209600" y="896760"/>
            <a:ext cx="914400" cy="660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Rectangle 51"/>
          <p:cNvSpPr/>
          <p:nvPr/>
        </p:nvSpPr>
        <p:spPr>
          <a:xfrm>
            <a:off x="2195640" y="896760"/>
            <a:ext cx="936360" cy="660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Rectangle 52"/>
          <p:cNvSpPr/>
          <p:nvPr/>
        </p:nvSpPr>
        <p:spPr>
          <a:xfrm>
            <a:off x="3203640" y="896760"/>
            <a:ext cx="1297080" cy="660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Rectangle 58"/>
          <p:cNvSpPr/>
          <p:nvPr/>
        </p:nvSpPr>
        <p:spPr>
          <a:xfrm>
            <a:off x="4643280" y="896760"/>
            <a:ext cx="1513080" cy="660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Rectangle 59"/>
          <p:cNvSpPr/>
          <p:nvPr/>
        </p:nvSpPr>
        <p:spPr>
          <a:xfrm>
            <a:off x="6300720" y="896760"/>
            <a:ext cx="1828800" cy="660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Text Box 10"/>
          <p:cNvSpPr/>
          <p:nvPr/>
        </p:nvSpPr>
        <p:spPr>
          <a:xfrm>
            <a:off x="2362320" y="2708280"/>
            <a:ext cx="10666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68 entries</a:t>
            </a:r>
            <a:r>
              <a:rPr b="0" lang="es-E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Text Box 11"/>
          <p:cNvSpPr/>
          <p:nvPr/>
        </p:nvSpPr>
        <p:spPr>
          <a:xfrm>
            <a:off x="3581280" y="2708280"/>
            <a:ext cx="10670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16 entries</a:t>
            </a:r>
            <a:r>
              <a:rPr b="0" lang="es-E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Text Box 12"/>
          <p:cNvSpPr/>
          <p:nvPr/>
        </p:nvSpPr>
        <p:spPr>
          <a:xfrm>
            <a:off x="5181480" y="2708280"/>
            <a:ext cx="10670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44 entries</a:t>
            </a:r>
            <a:r>
              <a:rPr b="0" lang="es-E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Text Box 13"/>
          <p:cNvSpPr/>
          <p:nvPr/>
        </p:nvSpPr>
        <p:spPr>
          <a:xfrm>
            <a:off x="6589800" y="2708280"/>
            <a:ext cx="1295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1507 entries</a:t>
            </a:r>
            <a:r>
              <a:rPr b="0" lang="es-E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Text Box 15"/>
          <p:cNvSpPr/>
          <p:nvPr/>
        </p:nvSpPr>
        <p:spPr>
          <a:xfrm>
            <a:off x="3200400" y="438480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Times New Roman"/>
              </a:rPr>
              <a:t>9 articles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Line 16"/>
          <p:cNvSpPr/>
          <p:nvPr/>
        </p:nvSpPr>
        <p:spPr>
          <a:xfrm>
            <a:off x="3733920" y="3927600"/>
            <a:ext cx="0" cy="3045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Line 21"/>
          <p:cNvSpPr/>
          <p:nvPr/>
        </p:nvSpPr>
        <p:spPr>
          <a:xfrm flipH="1">
            <a:off x="8458200" y="2898720"/>
            <a:ext cx="1440" cy="1333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Line 24"/>
          <p:cNvSpPr/>
          <p:nvPr/>
        </p:nvSpPr>
        <p:spPr>
          <a:xfrm>
            <a:off x="4419720" y="4613400"/>
            <a:ext cx="327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Text Box 25"/>
          <p:cNvSpPr/>
          <p:nvPr/>
        </p:nvSpPr>
        <p:spPr>
          <a:xfrm>
            <a:off x="4572000" y="5635800"/>
            <a:ext cx="2057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Times New Roman"/>
              </a:rPr>
              <a:t>17 article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Text Box 26"/>
          <p:cNvSpPr/>
          <p:nvPr/>
        </p:nvSpPr>
        <p:spPr>
          <a:xfrm>
            <a:off x="4724280" y="3927600"/>
            <a:ext cx="2895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Times New Roman"/>
              </a:rPr>
              <a:t>Survival data in human studies without receiving treatment with a targeted agen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Text Box 29"/>
          <p:cNvSpPr/>
          <p:nvPr/>
        </p:nvSpPr>
        <p:spPr>
          <a:xfrm>
            <a:off x="1143000" y="2708280"/>
            <a:ext cx="1341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1035 entries</a:t>
            </a:r>
            <a:r>
              <a:rPr b="0" lang="es-E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Line 30"/>
          <p:cNvSpPr/>
          <p:nvPr/>
        </p:nvSpPr>
        <p:spPr>
          <a:xfrm>
            <a:off x="1752480" y="3394080"/>
            <a:ext cx="0" cy="7621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Text Box 31"/>
          <p:cNvSpPr/>
          <p:nvPr/>
        </p:nvSpPr>
        <p:spPr>
          <a:xfrm>
            <a:off x="1143000" y="4384800"/>
            <a:ext cx="137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Times New Roman"/>
              </a:rPr>
              <a:t>5 articles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Rectangle 53"/>
          <p:cNvSpPr/>
          <p:nvPr/>
        </p:nvSpPr>
        <p:spPr>
          <a:xfrm>
            <a:off x="1143000" y="2784600"/>
            <a:ext cx="1052640" cy="380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Rectangle 54"/>
          <p:cNvSpPr/>
          <p:nvPr/>
        </p:nvSpPr>
        <p:spPr>
          <a:xfrm>
            <a:off x="2362320" y="2784600"/>
            <a:ext cx="914400" cy="380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Rectangle 55"/>
          <p:cNvSpPr/>
          <p:nvPr/>
        </p:nvSpPr>
        <p:spPr>
          <a:xfrm>
            <a:off x="3581280" y="2784600"/>
            <a:ext cx="990720" cy="380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Rectangle 56"/>
          <p:cNvSpPr/>
          <p:nvPr/>
        </p:nvSpPr>
        <p:spPr>
          <a:xfrm>
            <a:off x="5105520" y="2784600"/>
            <a:ext cx="990360" cy="380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Rectangle 57"/>
          <p:cNvSpPr/>
          <p:nvPr/>
        </p:nvSpPr>
        <p:spPr>
          <a:xfrm>
            <a:off x="6588000" y="2784600"/>
            <a:ext cx="1108080" cy="380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Rectangle 60"/>
          <p:cNvSpPr/>
          <p:nvPr/>
        </p:nvSpPr>
        <p:spPr>
          <a:xfrm>
            <a:off x="1143000" y="4384800"/>
            <a:ext cx="990720" cy="380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Rectangle 61"/>
          <p:cNvSpPr/>
          <p:nvPr/>
        </p:nvSpPr>
        <p:spPr>
          <a:xfrm>
            <a:off x="3200400" y="4384800"/>
            <a:ext cx="990720" cy="380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Rectangle 62"/>
          <p:cNvSpPr/>
          <p:nvPr/>
        </p:nvSpPr>
        <p:spPr>
          <a:xfrm>
            <a:off x="7848720" y="4384800"/>
            <a:ext cx="990360" cy="380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Rectangle 64"/>
          <p:cNvSpPr/>
          <p:nvPr/>
        </p:nvSpPr>
        <p:spPr>
          <a:xfrm>
            <a:off x="4572000" y="5538960"/>
            <a:ext cx="1219320" cy="457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AutoShape 70"/>
          <p:cNvSpPr/>
          <p:nvPr/>
        </p:nvSpPr>
        <p:spPr>
          <a:xfrm rot="5400000">
            <a:off x="4876920" y="802800"/>
            <a:ext cx="380880" cy="5562720"/>
          </a:xfrm>
          <a:custGeom>
            <a:avLst/>
            <a:gdLst>
              <a:gd name="textAreaLeft" fmla="*/ 0 w 380880"/>
              <a:gd name="textAreaRight" fmla="*/ 137520 w 380880"/>
              <a:gd name="textAreaTop" fmla="*/ 145080 h 5562720"/>
              <a:gd name="textAreaBottom" fmla="*/ 5417640 h 55627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14356"/>
                </a:lnTo>
                <a:cubicBezTo>
                  <a:pt x="10800" y="15256"/>
                  <a:pt x="16200" y="16156"/>
                  <a:pt x="21600" y="16156"/>
                </a:cubicBezTo>
                <a:cubicBezTo>
                  <a:pt x="16200" y="16156"/>
                  <a:pt x="10800" y="17056"/>
                  <a:pt x="10800" y="17956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AutoShape 71"/>
          <p:cNvSpPr/>
          <p:nvPr/>
        </p:nvSpPr>
        <p:spPr>
          <a:xfrm rot="5400000">
            <a:off x="4724280" y="1866600"/>
            <a:ext cx="533160" cy="6629400"/>
          </a:xfrm>
          <a:custGeom>
            <a:avLst/>
            <a:gdLst>
              <a:gd name="textAreaLeft" fmla="*/ 0 w 533160"/>
              <a:gd name="textAreaRight" fmla="*/ 192600 w 533160"/>
              <a:gd name="textAreaTop" fmla="*/ 172800 h 6629400"/>
              <a:gd name="textAreaBottom" fmla="*/ 6456600 h 6629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8627"/>
                </a:lnTo>
                <a:cubicBezTo>
                  <a:pt x="10800" y="9527"/>
                  <a:pt x="16200" y="10427"/>
                  <a:pt x="21600" y="10427"/>
                </a:cubicBezTo>
                <a:cubicBezTo>
                  <a:pt x="16200" y="10427"/>
                  <a:pt x="10800" y="11327"/>
                  <a:pt x="10800" y="12227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Line 72"/>
          <p:cNvSpPr/>
          <p:nvPr/>
        </p:nvSpPr>
        <p:spPr>
          <a:xfrm>
            <a:off x="2286000" y="4613400"/>
            <a:ext cx="838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Rectangle 57"/>
          <p:cNvSpPr/>
          <p:nvPr/>
        </p:nvSpPr>
        <p:spPr>
          <a:xfrm>
            <a:off x="7885080" y="1916280"/>
            <a:ext cx="1187640" cy="865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51 CuadroTexto"/>
          <p:cNvSpPr/>
          <p:nvPr/>
        </p:nvSpPr>
        <p:spPr>
          <a:xfrm>
            <a:off x="1600200" y="189000"/>
            <a:ext cx="6237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Human studies published in English between January 2002 and December 2012</a:t>
            </a:r>
            <a:r>
              <a:rPr b="0" lang="es-ES" sz="11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Line 28"/>
          <p:cNvSpPr/>
          <p:nvPr/>
        </p:nvSpPr>
        <p:spPr>
          <a:xfrm>
            <a:off x="2700360" y="1844640"/>
            <a:ext cx="0" cy="74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Line 28"/>
          <p:cNvSpPr/>
          <p:nvPr/>
        </p:nvSpPr>
        <p:spPr>
          <a:xfrm>
            <a:off x="3851280" y="1844640"/>
            <a:ext cx="0" cy="74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Line 28"/>
          <p:cNvSpPr/>
          <p:nvPr/>
        </p:nvSpPr>
        <p:spPr>
          <a:xfrm>
            <a:off x="5508720" y="1844640"/>
            <a:ext cx="0" cy="74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Line 28"/>
          <p:cNvSpPr/>
          <p:nvPr/>
        </p:nvSpPr>
        <p:spPr>
          <a:xfrm>
            <a:off x="6948360" y="1844640"/>
            <a:ext cx="0" cy="74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15T09:09:05Z</dcterms:created>
  <dc:creator>aaof07</dc:creator>
  <dc:description/>
  <dc:language>en-US</dc:language>
  <cp:lastModifiedBy>VeRo</cp:lastModifiedBy>
  <dcterms:modified xsi:type="dcterms:W3CDTF">2014-04-02T16:12:24Z</dcterms:modified>
  <cp:revision>17</cp:revision>
  <dc:subject/>
  <dc:title>Presentación de PowerPoint</dc:title>
</cp:coreProperties>
</file>